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C165C7-9A00-4B1D-8F7A-0E8A4EC6F7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E0FA0-DFE0-48C1-BB0A-31CDAC5B0B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210AD1-05C3-4C5B-BB8F-C950D8E891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95CC1A-C517-4581-B3D3-4EE3E07946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FBF08F-8B3C-465C-8764-3040ABD122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F67E86-4C1D-4917-BB5C-85604DCB8C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FC911-E9A3-4FBB-AC1A-358FB33857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E7645A-0FF1-4BED-B75E-DEE9AE142B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7954B4-811C-4987-B678-10A3876A44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42E8A-AFB3-45F9-A3B6-2267120C37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B2E8E-64B6-4BC7-A5B4-BA92EA346D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F50DF-8958-4998-B1C8-AFCA23CD4F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270BE6-2958-48D5-8A7A-3999E21555F8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rcRect l="0" t="17993" r="0" b="6106"/>
          <a:stretch/>
        </p:blipFill>
        <p:spPr>
          <a:xfrm>
            <a:off x="826920" y="385920"/>
            <a:ext cx="7317000" cy="444312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7600320" y="286056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7600320" y="338148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7600320" y="375768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800" spc="-1" strike="noStrike">
                <a:solidFill>
                  <a:srgbClr val="000000"/>
                </a:solidFill>
                <a:latin typeface="Arial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7600320" y="412596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800" spc="-1" strike="noStrike">
                <a:solidFill>
                  <a:srgbClr val="000000"/>
                </a:solidFill>
                <a:latin typeface="Arial"/>
              </a:rPr>
              <a:t>(D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"/>
          <p:cNvSpPr/>
          <p:nvPr/>
        </p:nvSpPr>
        <p:spPr>
          <a:xfrm>
            <a:off x="430200" y="5103720"/>
            <a:ext cx="7748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HPAEC-PAD analysis of post fermentation cell free supernatants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breve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CC2003, UCC2003-gal A  and complemented strain. Modified Rogosa  supplemented with 0.5 % GOS (A); Post fermentation supernatants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breve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CC2003 (B), UCC2003-galA-pBC1.2 (C) and UCC2003-galA-pBC1.2-galA (D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4" descr=""/>
          <p:cNvPicPr/>
          <p:nvPr/>
        </p:nvPicPr>
        <p:blipFill>
          <a:blip r:embed="rId1"/>
          <a:srcRect l="0" t="16627" r="0" b="10425"/>
          <a:stretch/>
        </p:blipFill>
        <p:spPr>
          <a:xfrm>
            <a:off x="971640" y="527040"/>
            <a:ext cx="7316640" cy="4270320"/>
          </a:xfrm>
          <a:prstGeom prst="rect">
            <a:avLst/>
          </a:prstGeom>
          <a:ln w="0">
            <a:noFill/>
          </a:ln>
        </p:spPr>
      </p:pic>
      <p:sp>
        <p:nvSpPr>
          <p:cNvPr id="48" name="TextBox 4"/>
          <p:cNvSpPr/>
          <p:nvPr/>
        </p:nvSpPr>
        <p:spPr>
          <a:xfrm>
            <a:off x="7618320" y="318780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6"/>
          <p:cNvSpPr/>
          <p:nvPr/>
        </p:nvSpPr>
        <p:spPr>
          <a:xfrm>
            <a:off x="7618320" y="370836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7"/>
          <p:cNvSpPr/>
          <p:nvPr/>
        </p:nvSpPr>
        <p:spPr>
          <a:xfrm>
            <a:off x="7618680" y="423072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800" spc="-1" strike="noStrike">
                <a:solidFill>
                  <a:srgbClr val="000000"/>
                </a:solidFill>
                <a:latin typeface="Arial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5"/>
          <p:cNvSpPr/>
          <p:nvPr/>
        </p:nvSpPr>
        <p:spPr>
          <a:xfrm>
            <a:off x="611280" y="5445000"/>
            <a:ext cx="83534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HPAEC-PAD analysis of post fermentation cell free supernatants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breve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CFB2257-pBC1.2, and GalA complemented derivative. Modified Rogosa  supplemented with 0.5 % GOS (A); Post fermentation supernatants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breve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CFB2257–pBC1.2 (B) 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 breve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CFB2257-pBC1.2 -galA (C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02T20:14:13Z</dcterms:created>
  <dc:creator>UCC</dc:creator>
  <dc:description/>
  <dc:language>en-US</dc:language>
  <cp:lastModifiedBy>mary</cp:lastModifiedBy>
  <dcterms:modified xsi:type="dcterms:W3CDTF">2012-10-02T20:47:16Z</dcterms:modified>
  <cp:revision>3</cp:revision>
  <dc:subject/>
  <dc:title>Slide 1</dc:title>
</cp:coreProperties>
</file>